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75" d="100"/>
          <a:sy n="75" d="100"/>
        </p:scale>
        <p:origin x="54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0F5C-1FB4-4089-A645-BEA8D762D8F4}" type="datetimeFigureOut">
              <a:rPr lang="en-US" smtClean="0"/>
              <a:t>1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4ACAD-EE48-406C-8B52-17E5A47E2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212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0F5C-1FB4-4089-A645-BEA8D762D8F4}" type="datetimeFigureOut">
              <a:rPr lang="en-US" smtClean="0"/>
              <a:t>1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4ACAD-EE48-406C-8B52-17E5A47E2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1313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0F5C-1FB4-4089-A645-BEA8D762D8F4}" type="datetimeFigureOut">
              <a:rPr lang="en-US" smtClean="0"/>
              <a:t>1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4ACAD-EE48-406C-8B52-17E5A47E2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222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0F5C-1FB4-4089-A645-BEA8D762D8F4}" type="datetimeFigureOut">
              <a:rPr lang="en-US" smtClean="0"/>
              <a:t>1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4ACAD-EE48-406C-8B52-17E5A47E2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342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0F5C-1FB4-4089-A645-BEA8D762D8F4}" type="datetimeFigureOut">
              <a:rPr lang="en-US" smtClean="0"/>
              <a:t>1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4ACAD-EE48-406C-8B52-17E5A47E2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2526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0F5C-1FB4-4089-A645-BEA8D762D8F4}" type="datetimeFigureOut">
              <a:rPr lang="en-US" smtClean="0"/>
              <a:t>1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4ACAD-EE48-406C-8B52-17E5A47E2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108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0F5C-1FB4-4089-A645-BEA8D762D8F4}" type="datetimeFigureOut">
              <a:rPr lang="en-US" smtClean="0"/>
              <a:t>1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4ACAD-EE48-406C-8B52-17E5A47E2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090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0F5C-1FB4-4089-A645-BEA8D762D8F4}" type="datetimeFigureOut">
              <a:rPr lang="en-US" smtClean="0"/>
              <a:t>1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4ACAD-EE48-406C-8B52-17E5A47E2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764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0F5C-1FB4-4089-A645-BEA8D762D8F4}" type="datetimeFigureOut">
              <a:rPr lang="en-US" smtClean="0"/>
              <a:t>1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4ACAD-EE48-406C-8B52-17E5A47E2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925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0F5C-1FB4-4089-A645-BEA8D762D8F4}" type="datetimeFigureOut">
              <a:rPr lang="en-US" smtClean="0"/>
              <a:t>1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4ACAD-EE48-406C-8B52-17E5A47E2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027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0F5C-1FB4-4089-A645-BEA8D762D8F4}" type="datetimeFigureOut">
              <a:rPr lang="en-US" smtClean="0"/>
              <a:t>1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4ACAD-EE48-406C-8B52-17E5A47E2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254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460F5C-1FB4-4089-A645-BEA8D762D8F4}" type="datetimeFigureOut">
              <a:rPr lang="en-US" smtClean="0"/>
              <a:t>1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A4ACAD-EE48-406C-8B52-17E5A47E2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738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/>
          <p:cNvGrpSpPr/>
          <p:nvPr/>
        </p:nvGrpSpPr>
        <p:grpSpPr>
          <a:xfrm>
            <a:off x="2750812" y="0"/>
            <a:ext cx="6693634" cy="6858000"/>
            <a:chOff x="2750812" y="0"/>
            <a:chExt cx="6693634" cy="685800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4055" y="0"/>
              <a:ext cx="6643890" cy="6858000"/>
            </a:xfrm>
            <a:prstGeom prst="rect">
              <a:avLst/>
            </a:prstGeom>
          </p:spPr>
        </p:pic>
        <p:cxnSp>
          <p:nvCxnSpPr>
            <p:cNvPr id="8" name="Straight Connector 7"/>
            <p:cNvCxnSpPr/>
            <p:nvPr/>
          </p:nvCxnSpPr>
          <p:spPr>
            <a:xfrm>
              <a:off x="7876903" y="6453050"/>
              <a:ext cx="1567543" cy="0"/>
            </a:xfrm>
            <a:prstGeom prst="line">
              <a:avLst/>
            </a:prstGeom>
            <a:ln w="1016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Rectangle 16"/>
            <p:cNvSpPr/>
            <p:nvPr/>
          </p:nvSpPr>
          <p:spPr>
            <a:xfrm>
              <a:off x="2750812" y="0"/>
              <a:ext cx="651140" cy="1015663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6000" b="1" cap="none" spc="0" dirty="0" smtClean="0">
                  <a:ln w="9525">
                    <a:solidFill>
                      <a:schemeClr val="bg1"/>
                    </a:solidFill>
                    <a:prstDash val="solid"/>
                  </a:ln>
                  <a:solidFill>
                    <a:schemeClr val="tx1"/>
                  </a:solidFill>
                  <a:effectLst>
                    <a:outerShdw blurRad="12700" dist="38100" dir="2700000" algn="tl" rotWithShape="0">
                      <a:schemeClr val="bg1">
                        <a:lumMod val="50000"/>
                      </a:schemeClr>
                    </a:outerShdw>
                  </a:effectLst>
                </a:rPr>
                <a:t>A</a:t>
              </a:r>
              <a:endParaRPr lang="en-US" sz="6000" b="1" cap="none" spc="0" dirty="0">
                <a:ln w="9525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blurRad="12700" dist="38100" dir="2700000" algn="tl" rotWithShape="0">
                    <a:schemeClr val="bg1">
                      <a:lumMod val="50000"/>
                    </a:schemeClr>
                  </a:outerShdw>
                </a:effectLst>
              </a:endParaRPr>
            </a:p>
          </p:txBody>
        </p:sp>
        <p:cxnSp>
          <p:nvCxnSpPr>
            <p:cNvPr id="25" name="Straight Arrow Connector 24"/>
            <p:cNvCxnSpPr/>
            <p:nvPr/>
          </p:nvCxnSpPr>
          <p:spPr>
            <a:xfrm flipH="1">
              <a:off x="6361611" y="1502229"/>
              <a:ext cx="496389" cy="418011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Rectangle 27"/>
            <p:cNvSpPr/>
            <p:nvPr/>
          </p:nvSpPr>
          <p:spPr>
            <a:xfrm>
              <a:off x="8087400" y="5831119"/>
              <a:ext cx="1050289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3200" b="1" dirty="0" smtClean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2 µm</a:t>
              </a:r>
              <a:endParaRPr lang="en-US" sz="3200" b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0208302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2774055" y="0"/>
            <a:ext cx="6658705" cy="6858000"/>
            <a:chOff x="2774055" y="0"/>
            <a:chExt cx="6658705" cy="685800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4055" y="0"/>
              <a:ext cx="6643890" cy="6858000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2862221" y="0"/>
              <a:ext cx="439544" cy="1015663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6000" b="1" dirty="0">
                  <a:ln w="9525">
                    <a:solidFill>
                      <a:schemeClr val="bg1"/>
                    </a:solidFill>
                    <a:prstDash val="solid"/>
                  </a:ln>
                  <a:effectLst>
                    <a:outerShdw blurRad="12700" dist="38100" dir="2700000" algn="tl" rotWithShape="0">
                      <a:schemeClr val="bg1">
                        <a:lumMod val="50000"/>
                      </a:schemeClr>
                    </a:outerShdw>
                  </a:effectLst>
                </a:rPr>
                <a:t>J</a:t>
              </a:r>
              <a:endParaRPr lang="en-US" sz="6000" b="1" cap="none" spc="0" dirty="0">
                <a:ln w="9525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blurRad="12700" dist="38100" dir="2700000" algn="tl" rotWithShape="0">
                    <a:schemeClr val="bg1">
                      <a:lumMod val="50000"/>
                    </a:schemeClr>
                  </a:outerShdw>
                </a:effectLst>
              </a:endParaRPr>
            </a:p>
          </p:txBody>
        </p:sp>
        <p:cxnSp>
          <p:nvCxnSpPr>
            <p:cNvPr id="6" name="Straight Connector 5"/>
            <p:cNvCxnSpPr/>
            <p:nvPr/>
          </p:nvCxnSpPr>
          <p:spPr>
            <a:xfrm flipV="1">
              <a:off x="8181474" y="6415894"/>
              <a:ext cx="1251286" cy="8969"/>
            </a:xfrm>
            <a:prstGeom prst="line">
              <a:avLst/>
            </a:prstGeom>
            <a:ln w="1016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Rectangle 7"/>
            <p:cNvSpPr/>
            <p:nvPr/>
          </p:nvSpPr>
          <p:spPr>
            <a:xfrm>
              <a:off x="8075368" y="5831119"/>
              <a:ext cx="1050289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3200" b="1" dirty="0" smtClean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2 µm</a:t>
              </a:r>
              <a:endParaRPr lang="en-US" sz="3200" b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7829948" y="2500061"/>
              <a:ext cx="490840" cy="83099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sz="4800" b="1" dirty="0">
                  <a:solidFill>
                    <a:prstClr val="black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*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4322570" y="4120407"/>
              <a:ext cx="490840" cy="83099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sz="4800" b="1" dirty="0">
                  <a:solidFill>
                    <a:prstClr val="black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*</a:t>
              </a:r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 flipH="1">
              <a:off x="8540355" y="1555589"/>
              <a:ext cx="605362" cy="321340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1307349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2774055" y="0"/>
            <a:ext cx="6646673" cy="6858000"/>
            <a:chOff x="2774055" y="0"/>
            <a:chExt cx="6646673" cy="685800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4055" y="0"/>
              <a:ext cx="6643890" cy="6858000"/>
            </a:xfrm>
            <a:prstGeom prst="rect">
              <a:avLst/>
            </a:prstGeom>
          </p:spPr>
        </p:pic>
        <p:cxnSp>
          <p:nvCxnSpPr>
            <p:cNvPr id="5" name="Straight Arrow Connector 4"/>
            <p:cNvCxnSpPr/>
            <p:nvPr/>
          </p:nvCxnSpPr>
          <p:spPr>
            <a:xfrm flipH="1">
              <a:off x="6783920" y="1339020"/>
              <a:ext cx="605362" cy="321340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Rectangle 5"/>
            <p:cNvSpPr/>
            <p:nvPr/>
          </p:nvSpPr>
          <p:spPr>
            <a:xfrm>
              <a:off x="2778865" y="0"/>
              <a:ext cx="606256" cy="1015663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6000" b="1" dirty="0" smtClean="0">
                  <a:ln w="9525">
                    <a:solidFill>
                      <a:schemeClr val="bg1"/>
                    </a:solidFill>
                    <a:prstDash val="solid"/>
                  </a:ln>
                  <a:effectLst>
                    <a:outerShdw blurRad="12700" dist="38100" dir="2700000" algn="tl" rotWithShape="0">
                      <a:schemeClr val="bg1">
                        <a:lumMod val="50000"/>
                      </a:schemeClr>
                    </a:outerShdw>
                  </a:effectLst>
                </a:rPr>
                <a:t>K</a:t>
              </a:r>
              <a:endParaRPr lang="en-US" sz="6000" b="1" cap="none" spc="0" dirty="0">
                <a:ln w="9525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blurRad="12700" dist="38100" dir="2700000" algn="tl" rotWithShape="0">
                    <a:schemeClr val="bg1">
                      <a:lumMod val="50000"/>
                    </a:schemeClr>
                  </a:outerShdw>
                </a:effectLst>
              </a:endParaRPr>
            </a:p>
          </p:txBody>
        </p:sp>
        <p:cxnSp>
          <p:nvCxnSpPr>
            <p:cNvPr id="7" name="Straight Connector 6"/>
            <p:cNvCxnSpPr/>
            <p:nvPr/>
          </p:nvCxnSpPr>
          <p:spPr>
            <a:xfrm>
              <a:off x="7880684" y="6412832"/>
              <a:ext cx="1540044" cy="3062"/>
            </a:xfrm>
            <a:prstGeom prst="line">
              <a:avLst/>
            </a:prstGeom>
            <a:ln w="1016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ectangle 8"/>
            <p:cNvSpPr/>
            <p:nvPr/>
          </p:nvSpPr>
          <p:spPr>
            <a:xfrm>
              <a:off x="7930991" y="5831119"/>
              <a:ext cx="1050288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3200" b="1" dirty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5</a:t>
              </a:r>
              <a:r>
                <a:rPr lang="en-US" sz="3200" b="1" dirty="0" smtClean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 µm</a:t>
              </a:r>
              <a:endParaRPr lang="en-US" sz="3200" b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678748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/>
          <p:cNvGrpSpPr/>
          <p:nvPr/>
        </p:nvGrpSpPr>
        <p:grpSpPr>
          <a:xfrm>
            <a:off x="2774055" y="0"/>
            <a:ext cx="6755586" cy="6858000"/>
            <a:chOff x="2774055" y="0"/>
            <a:chExt cx="6755586" cy="685800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4055" y="0"/>
              <a:ext cx="6643890" cy="6858000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2774055" y="0"/>
              <a:ext cx="615874" cy="1015663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6000" b="1" dirty="0">
                  <a:ln w="9525">
                    <a:solidFill>
                      <a:schemeClr val="bg1"/>
                    </a:solidFill>
                    <a:prstDash val="solid"/>
                  </a:ln>
                  <a:effectLst>
                    <a:outerShdw blurRad="12700" dist="38100" dir="2700000" algn="tl" rotWithShape="0">
                      <a:schemeClr val="bg1">
                        <a:lumMod val="50000"/>
                      </a:schemeClr>
                    </a:outerShdw>
                  </a:effectLst>
                </a:rPr>
                <a:t>B</a:t>
              </a:r>
              <a:endParaRPr lang="en-US" sz="6000" b="1" cap="none" spc="0" dirty="0">
                <a:ln w="9525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blurRad="12700" dist="38100" dir="2700000" algn="tl" rotWithShape="0">
                    <a:schemeClr val="bg1">
                      <a:lumMod val="50000"/>
                    </a:schemeClr>
                  </a:outerShdw>
                </a:effectLst>
              </a:endParaRPr>
            </a:p>
          </p:txBody>
        </p:sp>
        <p:cxnSp>
          <p:nvCxnSpPr>
            <p:cNvPr id="9" name="Straight Connector 8"/>
            <p:cNvCxnSpPr/>
            <p:nvPr/>
          </p:nvCxnSpPr>
          <p:spPr>
            <a:xfrm>
              <a:off x="8193505" y="6485019"/>
              <a:ext cx="1224440" cy="12031"/>
            </a:xfrm>
            <a:prstGeom prst="line">
              <a:avLst/>
            </a:prstGeom>
            <a:ln w="1016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 flipH="1">
              <a:off x="5991726" y="1335506"/>
              <a:ext cx="830179" cy="433136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 flipH="1">
              <a:off x="5991726" y="2298032"/>
              <a:ext cx="770021" cy="481262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 flipH="1">
              <a:off x="6821906" y="2863516"/>
              <a:ext cx="625641" cy="565484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 flipH="1">
              <a:off x="7447547" y="3982455"/>
              <a:ext cx="770021" cy="505324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/>
            <p:nvPr/>
          </p:nvCxnSpPr>
          <p:spPr>
            <a:xfrm flipH="1">
              <a:off x="7459578" y="4938963"/>
              <a:ext cx="757990" cy="472332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Rectangle 29"/>
            <p:cNvSpPr/>
            <p:nvPr/>
          </p:nvSpPr>
          <p:spPr>
            <a:xfrm>
              <a:off x="8081809" y="5912275"/>
              <a:ext cx="1447832" cy="584775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3200" b="1" dirty="0" smtClean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500 nm</a:t>
              </a:r>
              <a:endParaRPr lang="en-US" sz="3200" b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967588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2774055" y="0"/>
            <a:ext cx="6643890" cy="6858000"/>
            <a:chOff x="2774055" y="0"/>
            <a:chExt cx="6643890" cy="685800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4055" y="0"/>
              <a:ext cx="6643890" cy="6858000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2786077" y="0"/>
              <a:ext cx="591829" cy="1015663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6000" b="1" dirty="0">
                  <a:ln w="9525">
                    <a:solidFill>
                      <a:schemeClr val="bg1"/>
                    </a:solidFill>
                    <a:prstDash val="solid"/>
                  </a:ln>
                  <a:effectLst>
                    <a:outerShdw blurRad="12700" dist="38100" dir="2700000" algn="tl" rotWithShape="0">
                      <a:schemeClr val="bg1">
                        <a:lumMod val="50000"/>
                      </a:schemeClr>
                    </a:outerShdw>
                  </a:effectLst>
                </a:rPr>
                <a:t>C</a:t>
              </a:r>
              <a:endParaRPr lang="en-US" sz="6000" b="1" cap="none" spc="0" dirty="0">
                <a:ln w="9525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blurRad="12700" dist="38100" dir="2700000" algn="tl" rotWithShape="0">
                    <a:schemeClr val="bg1">
                      <a:lumMod val="50000"/>
                    </a:schemeClr>
                  </a:outerShdw>
                </a:effectLst>
              </a:endParaRPr>
            </a:p>
          </p:txBody>
        </p:sp>
        <p:cxnSp>
          <p:nvCxnSpPr>
            <p:cNvPr id="7" name="Straight Connector 6"/>
            <p:cNvCxnSpPr/>
            <p:nvPr/>
          </p:nvCxnSpPr>
          <p:spPr>
            <a:xfrm>
              <a:off x="7281746" y="6467707"/>
              <a:ext cx="2136199" cy="0"/>
            </a:xfrm>
            <a:prstGeom prst="line">
              <a:avLst/>
            </a:prstGeom>
            <a:ln w="1016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ectangle 8"/>
            <p:cNvSpPr/>
            <p:nvPr/>
          </p:nvSpPr>
          <p:spPr>
            <a:xfrm>
              <a:off x="7790221" y="5882932"/>
              <a:ext cx="1050288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3200" b="1" dirty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1</a:t>
              </a:r>
              <a:r>
                <a:rPr lang="en-US" sz="3200" b="1" dirty="0" smtClean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 µm</a:t>
              </a:r>
              <a:endParaRPr lang="en-US" sz="3200" b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sp>
          <p:nvSpPr>
            <p:cNvPr id="10" name="Isosceles Triangle 9"/>
            <p:cNvSpPr/>
            <p:nvPr/>
          </p:nvSpPr>
          <p:spPr>
            <a:xfrm rot="7952072">
              <a:off x="6743700" y="636073"/>
              <a:ext cx="354330" cy="29718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Isosceles Triangle 10"/>
            <p:cNvSpPr/>
            <p:nvPr/>
          </p:nvSpPr>
          <p:spPr>
            <a:xfrm rot="7952072">
              <a:off x="5509349" y="3637140"/>
              <a:ext cx="354330" cy="29718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Isosceles Triangle 11"/>
            <p:cNvSpPr/>
            <p:nvPr/>
          </p:nvSpPr>
          <p:spPr>
            <a:xfrm rot="7952072">
              <a:off x="5689574" y="1560071"/>
              <a:ext cx="354330" cy="29718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Isosceles Triangle 12"/>
            <p:cNvSpPr/>
            <p:nvPr/>
          </p:nvSpPr>
          <p:spPr>
            <a:xfrm rot="7952072">
              <a:off x="5363237" y="2490329"/>
              <a:ext cx="354330" cy="29718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Isosceles Triangle 13"/>
            <p:cNvSpPr/>
            <p:nvPr/>
          </p:nvSpPr>
          <p:spPr>
            <a:xfrm rot="7952072">
              <a:off x="4167750" y="3406139"/>
              <a:ext cx="354330" cy="29718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Isosceles Triangle 14"/>
            <p:cNvSpPr/>
            <p:nvPr/>
          </p:nvSpPr>
          <p:spPr>
            <a:xfrm rot="7952072">
              <a:off x="4481562" y="5089964"/>
              <a:ext cx="354330" cy="29718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9768311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Group 53"/>
          <p:cNvGrpSpPr/>
          <p:nvPr/>
        </p:nvGrpSpPr>
        <p:grpSpPr>
          <a:xfrm>
            <a:off x="2746804" y="0"/>
            <a:ext cx="6674549" cy="6858000"/>
            <a:chOff x="2746804" y="0"/>
            <a:chExt cx="6674549" cy="685800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4055" y="0"/>
              <a:ext cx="6643890" cy="685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" name="Rectangle 4"/>
            <p:cNvSpPr/>
            <p:nvPr/>
          </p:nvSpPr>
          <p:spPr>
            <a:xfrm>
              <a:off x="2746804" y="0"/>
              <a:ext cx="670376" cy="1015663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6000" b="1" dirty="0" smtClean="0">
                  <a:ln w="9525">
                    <a:solidFill>
                      <a:schemeClr val="bg1"/>
                    </a:solidFill>
                    <a:prstDash val="solid"/>
                  </a:ln>
                  <a:effectLst>
                    <a:outerShdw blurRad="12700" dist="38100" dir="2700000" algn="tl" rotWithShape="0">
                      <a:schemeClr val="bg1">
                        <a:lumMod val="50000"/>
                      </a:schemeClr>
                    </a:outerShdw>
                  </a:effectLst>
                </a:rPr>
                <a:t>D</a:t>
              </a:r>
              <a:endParaRPr lang="en-US" sz="6000" b="1" cap="none" spc="0" dirty="0">
                <a:ln w="9525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blurRad="12700" dist="38100" dir="2700000" algn="tl" rotWithShape="0">
                    <a:schemeClr val="bg1">
                      <a:lumMod val="50000"/>
                    </a:schemeClr>
                  </a:outerShdw>
                </a:effectLst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7913361" y="5912275"/>
              <a:ext cx="1447832" cy="584775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3200" b="1" dirty="0" smtClean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500 nm</a:t>
              </a:r>
              <a:endParaRPr lang="en-US" sz="3200" b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cxnSp>
          <p:nvCxnSpPr>
            <p:cNvPr id="39" name="Straight Connector 38"/>
            <p:cNvCxnSpPr/>
            <p:nvPr/>
          </p:nvCxnSpPr>
          <p:spPr>
            <a:xfrm>
              <a:off x="7880686" y="6497050"/>
              <a:ext cx="1540667" cy="0"/>
            </a:xfrm>
            <a:prstGeom prst="line">
              <a:avLst/>
            </a:prstGeom>
            <a:ln w="1016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/>
            <p:cNvCxnSpPr/>
            <p:nvPr/>
          </p:nvCxnSpPr>
          <p:spPr>
            <a:xfrm flipH="1">
              <a:off x="5723021" y="1696454"/>
              <a:ext cx="745958" cy="240631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/>
            <p:cNvCxnSpPr/>
            <p:nvPr/>
          </p:nvCxnSpPr>
          <p:spPr>
            <a:xfrm flipH="1">
              <a:off x="5253789" y="3633539"/>
              <a:ext cx="757989" cy="276725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47"/>
            <p:cNvCxnSpPr/>
            <p:nvPr/>
          </p:nvCxnSpPr>
          <p:spPr>
            <a:xfrm flipH="1">
              <a:off x="5083342" y="4866771"/>
              <a:ext cx="633663" cy="397041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Isosceles Triangle 50"/>
            <p:cNvSpPr/>
            <p:nvPr/>
          </p:nvSpPr>
          <p:spPr>
            <a:xfrm rot="6098457">
              <a:off x="7442244" y="1871285"/>
              <a:ext cx="317034" cy="311094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Isosceles Triangle 51"/>
            <p:cNvSpPr/>
            <p:nvPr/>
          </p:nvSpPr>
          <p:spPr>
            <a:xfrm rot="6098457">
              <a:off x="7127665" y="5208625"/>
              <a:ext cx="312821" cy="311094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Isosceles Triangle 52"/>
            <p:cNvSpPr/>
            <p:nvPr/>
          </p:nvSpPr>
          <p:spPr>
            <a:xfrm rot="6098457">
              <a:off x="6855187" y="3662571"/>
              <a:ext cx="312821" cy="311094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5287004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2774055" y="0"/>
            <a:ext cx="6658359" cy="6858000"/>
            <a:chOff x="2774055" y="0"/>
            <a:chExt cx="6658359" cy="685800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4055" y="0"/>
              <a:ext cx="6643890" cy="6858000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2802108" y="0"/>
              <a:ext cx="559769" cy="1015663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6000" b="1" dirty="0">
                  <a:ln w="9525">
                    <a:solidFill>
                      <a:schemeClr val="bg1"/>
                    </a:solidFill>
                    <a:prstDash val="solid"/>
                  </a:ln>
                  <a:effectLst>
                    <a:outerShdw blurRad="12700" dist="38100" dir="2700000" algn="tl" rotWithShape="0">
                      <a:schemeClr val="bg1">
                        <a:lumMod val="50000"/>
                      </a:schemeClr>
                    </a:outerShdw>
                  </a:effectLst>
                </a:rPr>
                <a:t>E</a:t>
              </a:r>
              <a:endParaRPr lang="en-US" sz="6000" b="1" cap="none" spc="0" dirty="0">
                <a:ln w="9525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blurRad="12700" dist="38100" dir="2700000" algn="tl" rotWithShape="0">
                    <a:schemeClr val="bg1">
                      <a:lumMod val="50000"/>
                    </a:schemeClr>
                  </a:outerShdw>
                </a:effectLst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8087400" y="5831119"/>
              <a:ext cx="1050289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3200" b="1" dirty="0" smtClean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2 µm</a:t>
              </a:r>
              <a:endParaRPr lang="en-US" sz="3200" b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cxnSp>
          <p:nvCxnSpPr>
            <p:cNvPr id="7" name="Straight Connector 6"/>
            <p:cNvCxnSpPr/>
            <p:nvPr/>
          </p:nvCxnSpPr>
          <p:spPr>
            <a:xfrm>
              <a:off x="7864871" y="6453050"/>
              <a:ext cx="1567543" cy="0"/>
            </a:xfrm>
            <a:prstGeom prst="line">
              <a:avLst/>
            </a:prstGeom>
            <a:ln w="1016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 flipH="1">
              <a:off x="7600176" y="188995"/>
              <a:ext cx="529390" cy="637672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6701590" y="1232230"/>
              <a:ext cx="348916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800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*</a:t>
              </a:r>
              <a:endParaRPr lang="en-US" sz="48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65885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2774055" y="0"/>
            <a:ext cx="6643890" cy="6858000"/>
            <a:chOff x="2774055" y="0"/>
            <a:chExt cx="6643890" cy="685800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4055" y="0"/>
              <a:ext cx="6643890" cy="6858000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2813329" y="0"/>
              <a:ext cx="537328" cy="1015663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6000" b="1" dirty="0" smtClean="0">
                  <a:ln w="9525">
                    <a:solidFill>
                      <a:schemeClr val="bg1"/>
                    </a:solidFill>
                    <a:prstDash val="solid"/>
                  </a:ln>
                  <a:effectLst>
                    <a:outerShdw blurRad="12700" dist="38100" dir="2700000" algn="tl" rotWithShape="0">
                      <a:schemeClr val="bg1">
                        <a:lumMod val="50000"/>
                      </a:schemeClr>
                    </a:outerShdw>
                  </a:effectLst>
                </a:rPr>
                <a:t>F</a:t>
              </a:r>
              <a:endParaRPr lang="en-US" sz="6000" b="1" cap="none" spc="0" dirty="0">
                <a:ln w="9525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blurRad="12700" dist="38100" dir="2700000" algn="tl" rotWithShape="0">
                    <a:schemeClr val="bg1">
                      <a:lumMod val="50000"/>
                    </a:schemeClr>
                  </a:outerShdw>
                </a:effectLst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8279913" y="5831119"/>
              <a:ext cx="1050288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3200" b="1" dirty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1</a:t>
              </a:r>
              <a:r>
                <a:rPr lang="en-US" sz="3200" b="1" dirty="0" smtClean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 µm</a:t>
              </a:r>
              <a:endParaRPr lang="en-US" sz="3200" b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cxnSp>
          <p:nvCxnSpPr>
            <p:cNvPr id="13" name="Straight Connector 12"/>
            <p:cNvCxnSpPr/>
            <p:nvPr/>
          </p:nvCxnSpPr>
          <p:spPr>
            <a:xfrm>
              <a:off x="8181474" y="6415894"/>
              <a:ext cx="1236471" cy="0"/>
            </a:xfrm>
            <a:prstGeom prst="line">
              <a:avLst/>
            </a:prstGeom>
            <a:ln w="1016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5317957" y="3465096"/>
              <a:ext cx="348916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800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*</a:t>
              </a:r>
              <a:endParaRPr lang="en-US" sz="48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 flipH="1">
              <a:off x="6938438" y="2490537"/>
              <a:ext cx="605362" cy="321340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1860300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2744401" y="12032"/>
            <a:ext cx="6673544" cy="7026442"/>
            <a:chOff x="2744401" y="0"/>
            <a:chExt cx="6673544" cy="7026442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4055" y="168442"/>
              <a:ext cx="6643890" cy="6858000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2744401" y="0"/>
              <a:ext cx="675185" cy="1015663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6000" b="1" dirty="0">
                  <a:ln w="9525">
                    <a:solidFill>
                      <a:schemeClr val="bg1"/>
                    </a:solidFill>
                    <a:prstDash val="solid"/>
                  </a:ln>
                  <a:effectLst>
                    <a:outerShdw blurRad="12700" dist="38100" dir="2700000" algn="tl" rotWithShape="0">
                      <a:schemeClr val="bg1">
                        <a:lumMod val="50000"/>
                      </a:schemeClr>
                    </a:outerShdw>
                  </a:effectLst>
                </a:rPr>
                <a:t>G</a:t>
              </a:r>
              <a:endParaRPr lang="en-US" sz="6000" b="1" cap="none" spc="0" dirty="0">
                <a:ln w="9525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blurRad="12700" dist="38100" dir="2700000" algn="tl" rotWithShape="0">
                    <a:schemeClr val="bg1">
                      <a:lumMod val="50000"/>
                    </a:schemeClr>
                  </a:outerShdw>
                </a:effectLst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8274564" y="6035663"/>
              <a:ext cx="1050289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3200" b="1" dirty="0" smtClean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2 µm</a:t>
              </a:r>
              <a:endParaRPr lang="en-US" sz="3200" b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cxnSp>
          <p:nvCxnSpPr>
            <p:cNvPr id="10" name="Straight Connector 9"/>
            <p:cNvCxnSpPr/>
            <p:nvPr/>
          </p:nvCxnSpPr>
          <p:spPr>
            <a:xfrm>
              <a:off x="8181474" y="6620438"/>
              <a:ext cx="1236471" cy="0"/>
            </a:xfrm>
            <a:prstGeom prst="line">
              <a:avLst/>
            </a:prstGeom>
            <a:ln w="1016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Rectangle 10"/>
            <p:cNvSpPr/>
            <p:nvPr/>
          </p:nvSpPr>
          <p:spPr>
            <a:xfrm>
              <a:off x="6885296" y="4397134"/>
              <a:ext cx="490840" cy="83099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sz="4800" b="1" dirty="0">
                  <a:solidFill>
                    <a:prstClr val="black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*</a:t>
              </a: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H="1">
              <a:off x="7878793" y="4563484"/>
              <a:ext cx="605362" cy="321340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353963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2746805" y="0"/>
            <a:ext cx="6671140" cy="6858000"/>
            <a:chOff x="2746805" y="0"/>
            <a:chExt cx="6671140" cy="685800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4055" y="0"/>
              <a:ext cx="6643890" cy="6858000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2746805" y="0"/>
              <a:ext cx="670376" cy="1015663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6000" b="1" dirty="0" smtClean="0">
                  <a:ln w="9525">
                    <a:solidFill>
                      <a:schemeClr val="bg1"/>
                    </a:solidFill>
                    <a:prstDash val="solid"/>
                  </a:ln>
                  <a:effectLst>
                    <a:outerShdw blurRad="12700" dist="38100" dir="2700000" algn="tl" rotWithShape="0">
                      <a:schemeClr val="bg1">
                        <a:lumMod val="50000"/>
                      </a:schemeClr>
                    </a:outerShdw>
                  </a:effectLst>
                </a:rPr>
                <a:t>H</a:t>
              </a:r>
              <a:endParaRPr lang="en-US" sz="6000" b="1" cap="none" spc="0" dirty="0">
                <a:ln w="9525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blurRad="12700" dist="38100" dir="2700000" algn="tl" rotWithShape="0">
                    <a:schemeClr val="bg1">
                      <a:lumMod val="50000"/>
                    </a:schemeClr>
                  </a:outerShdw>
                </a:effectLst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7509892" y="5831119"/>
              <a:ext cx="1050288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3200" b="1" dirty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1</a:t>
              </a:r>
              <a:r>
                <a:rPr lang="en-US" sz="3200" b="1" dirty="0" smtClean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 µm</a:t>
              </a:r>
              <a:endParaRPr lang="en-US" sz="3200" b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cxnSp>
          <p:nvCxnSpPr>
            <p:cNvPr id="8" name="Straight Connector 7"/>
            <p:cNvCxnSpPr/>
            <p:nvPr/>
          </p:nvCxnSpPr>
          <p:spPr>
            <a:xfrm>
              <a:off x="7603958" y="6415894"/>
              <a:ext cx="1804738" cy="0"/>
            </a:xfrm>
            <a:prstGeom prst="line">
              <a:avLst/>
            </a:prstGeom>
            <a:ln w="1016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Rectangle 10"/>
            <p:cNvSpPr/>
            <p:nvPr/>
          </p:nvSpPr>
          <p:spPr>
            <a:xfrm>
              <a:off x="6668728" y="3013501"/>
              <a:ext cx="490840" cy="83099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sz="4800" b="1" dirty="0">
                  <a:solidFill>
                    <a:prstClr val="black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*</a:t>
              </a: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H="1">
              <a:off x="8408183" y="1447305"/>
              <a:ext cx="605362" cy="321340"/>
            </a:xfrm>
            <a:prstGeom prst="straightConnector1">
              <a:avLst/>
            </a:prstGeom>
            <a:ln w="1016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30175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4055" y="0"/>
            <a:ext cx="6643890" cy="6858000"/>
          </a:xfrm>
          <a:prstGeom prst="rect">
            <a:avLst/>
          </a:prstGeom>
        </p:spPr>
      </p:pic>
      <p:grpSp>
        <p:nvGrpSpPr>
          <p:cNvPr id="12" name="Group 11"/>
          <p:cNvGrpSpPr/>
          <p:nvPr/>
        </p:nvGrpSpPr>
        <p:grpSpPr>
          <a:xfrm>
            <a:off x="2774055" y="0"/>
            <a:ext cx="6646673" cy="6858000"/>
            <a:chOff x="2774055" y="0"/>
            <a:chExt cx="6646673" cy="685800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4055" y="0"/>
              <a:ext cx="6643890" cy="6858000"/>
            </a:xfrm>
            <a:prstGeom prst="rect">
              <a:avLst/>
            </a:prstGeom>
          </p:spPr>
        </p:pic>
        <p:grpSp>
          <p:nvGrpSpPr>
            <p:cNvPr id="11" name="Group 10"/>
            <p:cNvGrpSpPr/>
            <p:nvPr/>
          </p:nvGrpSpPr>
          <p:grpSpPr>
            <a:xfrm>
              <a:off x="2887068" y="0"/>
              <a:ext cx="6533660" cy="6415894"/>
              <a:chOff x="2887068" y="0"/>
              <a:chExt cx="6533660" cy="6415894"/>
            </a:xfrm>
          </p:grpSpPr>
          <p:sp>
            <p:nvSpPr>
              <p:cNvPr id="6" name="Rectangle 5"/>
              <p:cNvSpPr/>
              <p:nvPr/>
            </p:nvSpPr>
            <p:spPr>
              <a:xfrm>
                <a:off x="2887068" y="0"/>
                <a:ext cx="389851" cy="1015663"/>
              </a:xfrm>
              <a:prstGeom prst="rect">
                <a:avLst/>
              </a:prstGeom>
              <a:noFill/>
            </p:spPr>
            <p:txBody>
              <a:bodyPr wrap="none" lIns="91440" tIns="45720" rIns="91440" bIns="45720">
                <a:spAutoFit/>
              </a:bodyPr>
              <a:lstStyle/>
              <a:p>
                <a:pPr algn="ctr"/>
                <a:r>
                  <a:rPr lang="en-US" sz="6000" b="1" dirty="0">
                    <a:ln w="9525">
                      <a:solidFill>
                        <a:schemeClr val="bg1"/>
                      </a:solidFill>
                      <a:prstDash val="solid"/>
                    </a:ln>
                    <a:effectLst>
                      <a:outerShdw blurRad="12700" dist="38100" dir="2700000" algn="tl" rotWithShape="0">
                        <a:schemeClr val="bg1">
                          <a:lumMod val="50000"/>
                        </a:schemeClr>
                      </a:outerShdw>
                    </a:effectLst>
                  </a:rPr>
                  <a:t>I</a:t>
                </a:r>
                <a:endParaRPr lang="en-US" sz="6000" b="1" cap="none" spc="0" dirty="0">
                  <a:ln w="9525">
                    <a:solidFill>
                      <a:schemeClr val="bg1"/>
                    </a:solidFill>
                    <a:prstDash val="solid"/>
                  </a:ln>
                  <a:solidFill>
                    <a:schemeClr val="tx1"/>
                  </a:solidFill>
                  <a:effectLst>
                    <a:outerShdw blurRad="12700" dist="38100" dir="2700000" algn="tl" rotWithShape="0">
                      <a:schemeClr val="bg1">
                        <a:lumMod val="50000"/>
                      </a:schemeClr>
                    </a:outerShdw>
                  </a:effectLst>
                </a:endParaRPr>
              </a:p>
            </p:txBody>
          </p:sp>
          <p:cxnSp>
            <p:nvCxnSpPr>
              <p:cNvPr id="7" name="Straight Connector 6"/>
              <p:cNvCxnSpPr/>
              <p:nvPr/>
            </p:nvCxnSpPr>
            <p:spPr>
              <a:xfrm>
                <a:off x="7880684" y="6412832"/>
                <a:ext cx="1540044" cy="3062"/>
              </a:xfrm>
              <a:prstGeom prst="line">
                <a:avLst/>
              </a:prstGeom>
              <a:ln w="1016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Rectangle 7"/>
              <p:cNvSpPr/>
              <p:nvPr/>
            </p:nvSpPr>
            <p:spPr>
              <a:xfrm>
                <a:off x="7798632" y="5831119"/>
                <a:ext cx="1050289" cy="58477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3200" b="1" dirty="0" smtClean="0">
                    <a:ln w="0"/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</a:rPr>
                  <a:t>2 µm</a:t>
                </a:r>
                <a:endParaRPr lang="en-US" sz="3200" b="1" dirty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endParaRPr>
              </a:p>
            </p:txBody>
          </p:sp>
          <p:sp>
            <p:nvSpPr>
              <p:cNvPr id="9" name="Rectangle 8"/>
              <p:cNvSpPr/>
              <p:nvPr/>
            </p:nvSpPr>
            <p:spPr>
              <a:xfrm>
                <a:off x="5754328" y="3013501"/>
                <a:ext cx="490840" cy="83099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en-US" sz="4800" b="1" dirty="0">
                    <a:solidFill>
                      <a:prstClr val="black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</a:rPr>
                  <a:t>*</a:t>
                </a:r>
              </a:p>
            </p:txBody>
          </p:sp>
          <p:cxnSp>
            <p:nvCxnSpPr>
              <p:cNvPr id="10" name="Straight Arrow Connector 9"/>
              <p:cNvCxnSpPr/>
              <p:nvPr/>
            </p:nvCxnSpPr>
            <p:spPr>
              <a:xfrm flipH="1">
                <a:off x="6615477" y="2036853"/>
                <a:ext cx="605362" cy="321340"/>
              </a:xfrm>
              <a:prstGeom prst="straightConnector1">
                <a:avLst/>
              </a:prstGeom>
              <a:ln w="1016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812355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3</TotalTime>
  <Words>40</Words>
  <Application>Microsoft Office PowerPoint</Application>
  <PresentationFormat>แบบจอกว้าง</PresentationFormat>
  <Paragraphs>29</Paragraphs>
  <Slides>1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3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m-02</dc:creator>
  <cp:lastModifiedBy>Windows User</cp:lastModifiedBy>
  <cp:revision>21</cp:revision>
  <dcterms:created xsi:type="dcterms:W3CDTF">2020-01-04T07:59:32Z</dcterms:created>
  <dcterms:modified xsi:type="dcterms:W3CDTF">2020-01-08T03:02:07Z</dcterms:modified>
</cp:coreProperties>
</file>